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20507D-7388-41C1-B388-375153F6576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2DE30B-7EBB-4315-B8A4-5ECC328F5A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AB83BD-88E8-46EA-878D-F963B736D24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1C0880-6604-424F-B267-AAE3ECE7F90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E1386F-5388-4127-98B0-C2EDF089AB0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633B89-F8B1-4264-8958-4895945C3A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96A94F-18DF-4B3A-8E88-D86BB385BF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B6C021-271A-40FC-BB3C-13F0484755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1E9C60-5CA2-42FC-BA99-31F3E4ED53D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2F529E-088D-4430-89C6-645D45A1F9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C3EFE0-2910-4918-8C1E-B503FBBDBD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94C697-CD11-4694-8ACD-9EE44EC695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444059E-6731-44DF-84BA-EAA4B1915A8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500200" y="1011240"/>
            <a:ext cx="47340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2500200" y="1011240"/>
            <a:ext cx="4734000" cy="1914480"/>
          </a:xfrm>
          <a:prstGeom prst="rect">
            <a:avLst/>
          </a:prstGeom>
          <a:noFill/>
          <a:ln w="93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595600" y="1935000"/>
            <a:ext cx="123840" cy="9907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538440" y="2049480"/>
            <a:ext cx="123840" cy="87624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4491000" y="1935000"/>
            <a:ext cx="123840" cy="99072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5433840" y="1906560"/>
            <a:ext cx="123840" cy="101916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6386400" y="1335240"/>
            <a:ext cx="123840" cy="159048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2719440" y="2382840"/>
            <a:ext cx="123840" cy="5428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662280" y="2306520"/>
            <a:ext cx="133560" cy="61920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4614840" y="2259000"/>
            <a:ext cx="123840" cy="66672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5557680" y="2363760"/>
            <a:ext cx="133560" cy="56196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6510240" y="2468520"/>
            <a:ext cx="123840" cy="45720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843280" y="2525760"/>
            <a:ext cx="133200" cy="3999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3795840" y="2535120"/>
            <a:ext cx="123840" cy="39060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4738680" y="2573280"/>
            <a:ext cx="133200" cy="35244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5691240" y="2535120"/>
            <a:ext cx="123840" cy="39060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6634080" y="2697120"/>
            <a:ext cx="133560" cy="22860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2976480" y="2583000"/>
            <a:ext cx="123840" cy="3427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919680" y="2592360"/>
            <a:ext cx="123840" cy="33336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4871880" y="2611440"/>
            <a:ext cx="123840" cy="3142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5815080" y="2611440"/>
            <a:ext cx="123840" cy="31428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6767640" y="2725560"/>
            <a:ext cx="123840" cy="20016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100320" y="2611440"/>
            <a:ext cx="123840" cy="3142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4043520" y="2611440"/>
            <a:ext cx="133200" cy="3142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4995720" y="2678040"/>
            <a:ext cx="123840" cy="2476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5938920" y="2630520"/>
            <a:ext cx="133200" cy="29520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6891480" y="2744640"/>
            <a:ext cx="123840" cy="18108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3224160" y="2773440"/>
            <a:ext cx="123840" cy="1522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4176720" y="2725560"/>
            <a:ext cx="123840" cy="20016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5119560" y="2763720"/>
            <a:ext cx="123840" cy="16200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6072120" y="2763720"/>
            <a:ext cx="123840" cy="16200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7015320" y="2849400"/>
            <a:ext cx="123840" cy="7632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2500200" y="1011240"/>
            <a:ext cx="1800" cy="1914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2462040" y="2925720"/>
            <a:ext cx="381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2500200" y="2925720"/>
            <a:ext cx="47340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 flipV="1">
            <a:off x="2500200" y="292572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 flipV="1">
            <a:off x="3443400" y="292572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 flipV="1">
            <a:off x="4395960" y="292572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 flipV="1">
            <a:off x="5338800" y="292572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 flipV="1">
            <a:off x="6291360" y="292572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 flipV="1">
            <a:off x="7234200" y="292572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3727800" y="544680"/>
            <a:ext cx="1069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Arial"/>
              </a:rPr>
              <a:t>samtool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5510880" y="544680"/>
            <a:ext cx="1306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reads2snp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2649600" y="571680"/>
            <a:ext cx="496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WF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3719160" y="2997360"/>
            <a:ext cx="31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5668560" y="2995560"/>
            <a:ext cx="31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4627080" y="2995560"/>
            <a:ext cx="46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6581160" y="2995560"/>
            <a:ext cx="46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2500200" y="4014720"/>
            <a:ext cx="47340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2500200" y="4014720"/>
            <a:ext cx="4734000" cy="1914480"/>
          </a:xfrm>
          <a:prstGeom prst="rect">
            <a:avLst/>
          </a:prstGeom>
          <a:noFill/>
          <a:ln w="93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2595600" y="4938840"/>
            <a:ext cx="123840" cy="9903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3538440" y="4948200"/>
            <a:ext cx="123840" cy="98100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4491000" y="4900680"/>
            <a:ext cx="123840" cy="102852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5433840" y="4871880"/>
            <a:ext cx="123840" cy="105732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6386400" y="4710240"/>
            <a:ext cx="123840" cy="121896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2719440" y="5386320"/>
            <a:ext cx="123840" cy="5428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3662280" y="5376960"/>
            <a:ext cx="133560" cy="55224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4614840" y="5338800"/>
            <a:ext cx="123840" cy="59040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5557680" y="5462640"/>
            <a:ext cx="133560" cy="46656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6510240" y="5491080"/>
            <a:ext cx="123840" cy="43812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2843280" y="5529240"/>
            <a:ext cx="133200" cy="3999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3795840" y="5548320"/>
            <a:ext cx="123840" cy="3808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4738680" y="5595840"/>
            <a:ext cx="133200" cy="33336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5691240" y="5538960"/>
            <a:ext cx="123840" cy="39024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6634080" y="5624640"/>
            <a:ext cx="133560" cy="30456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2976480" y="5586480"/>
            <a:ext cx="123840" cy="3427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3919680" y="5595840"/>
            <a:ext cx="123840" cy="33336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4871880" y="5653080"/>
            <a:ext cx="123840" cy="27612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5815080" y="5605560"/>
            <a:ext cx="123840" cy="32364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6767640" y="5624640"/>
            <a:ext cx="123840" cy="30456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3100320" y="5614920"/>
            <a:ext cx="123840" cy="3142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4043520" y="5614920"/>
            <a:ext cx="133200" cy="3142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4995720" y="5614920"/>
            <a:ext cx="123840" cy="3142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5938920" y="5605560"/>
            <a:ext cx="133200" cy="32364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6891480" y="5614920"/>
            <a:ext cx="123840" cy="31428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3224160" y="5776920"/>
            <a:ext cx="123840" cy="1522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4176720" y="5757840"/>
            <a:ext cx="123840" cy="17136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5119560" y="5738760"/>
            <a:ext cx="123840" cy="19044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6072120" y="5767560"/>
            <a:ext cx="123840" cy="16164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7015320" y="5776920"/>
            <a:ext cx="123840" cy="15228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2500200" y="4014720"/>
            <a:ext cx="1800" cy="1914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2462040" y="5929200"/>
            <a:ext cx="381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2500200" y="5929200"/>
            <a:ext cx="47340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 flipV="1">
            <a:off x="2500200" y="592920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 flipV="1">
            <a:off x="3443400" y="592920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 flipV="1">
            <a:off x="4395960" y="592920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 flipV="1">
            <a:off x="5338800" y="592920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 flipV="1">
            <a:off x="6291360" y="592920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 flipV="1">
            <a:off x="7234200" y="592920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3725640" y="5972040"/>
            <a:ext cx="31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5675040" y="5970600"/>
            <a:ext cx="31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4633560" y="5970600"/>
            <a:ext cx="46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6587640" y="5970600"/>
            <a:ext cx="46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3727800" y="3594240"/>
            <a:ext cx="1069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Arial"/>
              </a:rPr>
              <a:t>samtool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5510880" y="3594240"/>
            <a:ext cx="1306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reads2snp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2649600" y="3621240"/>
            <a:ext cx="496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WF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755640" y="828720"/>
            <a:ext cx="816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Turtl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755640" y="3854520"/>
            <a:ext cx="816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Cion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5506920" y="1479600"/>
            <a:ext cx="587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-0.0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6523200" y="1481040"/>
            <a:ext cx="587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-0.9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5526360" y="4505400"/>
            <a:ext cx="52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0.0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6541920" y="4506840"/>
            <a:ext cx="587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-0.4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3635280" y="4505400"/>
            <a:ext cx="587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-0.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4651200" y="4506840"/>
            <a:ext cx="587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-0.3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3614760" y="1481040"/>
            <a:ext cx="52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0.1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4630680" y="1482840"/>
            <a:ext cx="587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-0.3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"/>
          <p:cNvSpPr/>
          <p:nvPr/>
        </p:nvSpPr>
        <p:spPr>
          <a:xfrm>
            <a:off x="2502000" y="1015920"/>
            <a:ext cx="47340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2502000" y="1015920"/>
            <a:ext cx="4734000" cy="1914480"/>
          </a:xfrm>
          <a:prstGeom prst="rect">
            <a:avLst/>
          </a:prstGeom>
          <a:noFill/>
          <a:ln w="93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2597040" y="1940040"/>
            <a:ext cx="123840" cy="9903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3540240" y="1930320"/>
            <a:ext cx="123840" cy="10000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4492800" y="1778040"/>
            <a:ext cx="123480" cy="115236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5435640" y="2025720"/>
            <a:ext cx="123840" cy="90468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6388200" y="1720800"/>
            <a:ext cx="123840" cy="120960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2720880" y="2387520"/>
            <a:ext cx="123840" cy="5428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3664080" y="2292480"/>
            <a:ext cx="133200" cy="63792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4616280" y="2254320"/>
            <a:ext cx="123840" cy="6760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5559480" y="2320920"/>
            <a:ext cx="133200" cy="60948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6512040" y="2340000"/>
            <a:ext cx="123840" cy="59040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2844720" y="2530440"/>
            <a:ext cx="133560" cy="3999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3797280" y="2549520"/>
            <a:ext cx="123840" cy="3808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4740120" y="2606760"/>
            <a:ext cx="133560" cy="32364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5692680" y="2521080"/>
            <a:ext cx="123840" cy="40932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6635880" y="2616120"/>
            <a:ext cx="133200" cy="31428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2978280" y="2587680"/>
            <a:ext cx="123840" cy="3427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3921120" y="2625840"/>
            <a:ext cx="123840" cy="30456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4873680" y="2701800"/>
            <a:ext cx="123840" cy="22860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5816520" y="2597040"/>
            <a:ext cx="123840" cy="33336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6769080" y="2664000"/>
            <a:ext cx="123840" cy="26640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3102120" y="2616120"/>
            <a:ext cx="123840" cy="3142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4044960" y="2654280"/>
            <a:ext cx="133200" cy="27612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4997520" y="2692440"/>
            <a:ext cx="123840" cy="23796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5940360" y="2616120"/>
            <a:ext cx="133560" cy="31428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6892920" y="2701800"/>
            <a:ext cx="123840" cy="22860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3225960" y="2778120"/>
            <a:ext cx="123840" cy="1522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4178160" y="2787480"/>
            <a:ext cx="123840" cy="14292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5121360" y="2806560"/>
            <a:ext cx="123840" cy="12384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6073920" y="2768760"/>
            <a:ext cx="123840" cy="16164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7016760" y="2806560"/>
            <a:ext cx="123840" cy="12384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2502000" y="1015920"/>
            <a:ext cx="1440" cy="1914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2463840" y="2930400"/>
            <a:ext cx="381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2502000" y="2930400"/>
            <a:ext cx="47340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 flipV="1">
            <a:off x="2502000" y="293040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 flipV="1">
            <a:off x="3444840" y="293040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 flipV="1">
            <a:off x="4397400" y="293040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 flipV="1">
            <a:off x="5340240" y="293040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 flipV="1">
            <a:off x="6292800" y="293040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 flipV="1">
            <a:off x="7236000" y="293040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3729240" y="549360"/>
            <a:ext cx="1069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Arial"/>
              </a:rPr>
              <a:t>samtool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5512320" y="549360"/>
            <a:ext cx="1306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reads2snp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2651400" y="576360"/>
            <a:ext cx="496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WF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3720600" y="3002040"/>
            <a:ext cx="31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5670000" y="3000240"/>
            <a:ext cx="31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4628520" y="3000240"/>
            <a:ext cx="46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6582960" y="3000240"/>
            <a:ext cx="46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3727080" y="5951520"/>
            <a:ext cx="31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5676480" y="5950080"/>
            <a:ext cx="31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4635000" y="5950080"/>
            <a:ext cx="46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6589080" y="5950080"/>
            <a:ext cx="46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3729240" y="3573360"/>
            <a:ext cx="1069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Arial"/>
              </a:rPr>
              <a:t>samtool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5512320" y="3573360"/>
            <a:ext cx="1306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reads2snp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2651400" y="3600360"/>
            <a:ext cx="496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WF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757800" y="833400"/>
            <a:ext cx="903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Oyst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757800" y="3833640"/>
            <a:ext cx="1005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Termit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2496960" y="4048200"/>
            <a:ext cx="47340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2496960" y="4048200"/>
            <a:ext cx="4734000" cy="1914480"/>
          </a:xfrm>
          <a:prstGeom prst="rect">
            <a:avLst/>
          </a:prstGeom>
          <a:noFill/>
          <a:ln w="93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2592360" y="4971960"/>
            <a:ext cx="123840" cy="9907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3535200" y="5229360"/>
            <a:ext cx="123840" cy="73332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4487760" y="5210280"/>
            <a:ext cx="123840" cy="75240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5430960" y="4991040"/>
            <a:ext cx="123840" cy="97164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6383160" y="4619520"/>
            <a:ext cx="123840" cy="134316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>
            <a:off x="2716200" y="5419800"/>
            <a:ext cx="123840" cy="5428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3659040" y="5324400"/>
            <a:ext cx="133560" cy="6382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4611600" y="5353200"/>
            <a:ext cx="123840" cy="6094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5554800" y="5410080"/>
            <a:ext cx="133200" cy="55260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6507000" y="5495760"/>
            <a:ext cx="123840" cy="46692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2840040" y="5562720"/>
            <a:ext cx="133200" cy="3999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3792600" y="5524560"/>
            <a:ext cx="123840" cy="43812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4735440" y="5543640"/>
            <a:ext cx="133560" cy="41904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5688000" y="5581800"/>
            <a:ext cx="123840" cy="38088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6630840" y="5657760"/>
            <a:ext cx="133560" cy="30492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2973240" y="5619600"/>
            <a:ext cx="123840" cy="3430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3916440" y="5562720"/>
            <a:ext cx="123840" cy="39996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4869000" y="5581800"/>
            <a:ext cx="123840" cy="3808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5811840" y="5600880"/>
            <a:ext cx="123840" cy="36180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6764400" y="5695920"/>
            <a:ext cx="123840" cy="26676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3097080" y="5648400"/>
            <a:ext cx="123840" cy="3142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4040280" y="5610240"/>
            <a:ext cx="133200" cy="35244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4992840" y="5572080"/>
            <a:ext cx="123840" cy="39060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5935680" y="5657760"/>
            <a:ext cx="133200" cy="30492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6888240" y="5715000"/>
            <a:ext cx="123840" cy="24768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>
            <a:off x="3220920" y="5810400"/>
            <a:ext cx="123840" cy="1522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4173480" y="5781600"/>
            <a:ext cx="123840" cy="1810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5116680" y="5772240"/>
            <a:ext cx="123480" cy="19044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6068880" y="5800680"/>
            <a:ext cx="123840" cy="16200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7012080" y="5848200"/>
            <a:ext cx="123840" cy="11448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2496960" y="4048200"/>
            <a:ext cx="1800" cy="1914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2459160" y="5962680"/>
            <a:ext cx="378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2496960" y="5962680"/>
            <a:ext cx="47340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 flipV="1">
            <a:off x="2496960" y="596268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 flipV="1">
            <a:off x="3440160" y="596268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 flipV="1">
            <a:off x="4392720" y="596268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 flipV="1">
            <a:off x="5335560" y="596268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 flipV="1">
            <a:off x="6288120" y="596268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 flipV="1">
            <a:off x="7230960" y="596268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5508720" y="1484280"/>
            <a:ext cx="587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-0.0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6524640" y="1486080"/>
            <a:ext cx="587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-0.2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5527800" y="4510080"/>
            <a:ext cx="587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-0.0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6543720" y="4511520"/>
            <a:ext cx="587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-0.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>
            <a:off x="3616560" y="1486080"/>
            <a:ext cx="52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0.0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>
            <a:off x="4632480" y="1487520"/>
            <a:ext cx="587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-0.0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3637080" y="4510080"/>
            <a:ext cx="52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0.3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4653000" y="4511520"/>
            <a:ext cx="52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0.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60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26T15:17:04Z</dcterms:created>
  <dc:creator>GALTIER</dc:creator>
  <dc:description/>
  <dc:language>en-US</dc:language>
  <cp:lastModifiedBy>GALTIER</cp:lastModifiedBy>
  <dcterms:modified xsi:type="dcterms:W3CDTF">2012-12-29T23:06:23Z</dcterms:modified>
  <cp:revision>107</cp:revision>
  <dc:subject/>
  <dc:title>Diapositive 1</dc:title>
</cp:coreProperties>
</file>